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156325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204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261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1725" y="1122363"/>
            <a:ext cx="5232876" cy="2387600"/>
          </a:xfrm>
        </p:spPr>
        <p:txBody>
          <a:bodyPr anchor="b"/>
          <a:lstStyle>
            <a:lvl1pPr algn="ctr">
              <a:defRPr sz="40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9541" y="3602038"/>
            <a:ext cx="4617244" cy="1655762"/>
          </a:xfrm>
        </p:spPr>
        <p:txBody>
          <a:bodyPr/>
          <a:lstStyle>
            <a:lvl1pPr marL="0" indent="0" algn="ctr">
              <a:buNone/>
              <a:defRPr sz="1616"/>
            </a:lvl1pPr>
            <a:lvl2pPr marL="307833" indent="0" algn="ctr">
              <a:buNone/>
              <a:defRPr sz="1347"/>
            </a:lvl2pPr>
            <a:lvl3pPr marL="615666" indent="0" algn="ctr">
              <a:buNone/>
              <a:defRPr sz="1212"/>
            </a:lvl3pPr>
            <a:lvl4pPr marL="923498" indent="0" algn="ctr">
              <a:buNone/>
              <a:defRPr sz="1077"/>
            </a:lvl4pPr>
            <a:lvl5pPr marL="1231331" indent="0" algn="ctr">
              <a:buNone/>
              <a:defRPr sz="1077"/>
            </a:lvl5pPr>
            <a:lvl6pPr marL="1539164" indent="0" algn="ctr">
              <a:buNone/>
              <a:defRPr sz="1077"/>
            </a:lvl6pPr>
            <a:lvl7pPr marL="1846997" indent="0" algn="ctr">
              <a:buNone/>
              <a:defRPr sz="1077"/>
            </a:lvl7pPr>
            <a:lvl8pPr marL="2154829" indent="0" algn="ctr">
              <a:buNone/>
              <a:defRPr sz="1077"/>
            </a:lvl8pPr>
            <a:lvl9pPr marL="2462662" indent="0" algn="ctr">
              <a:buNone/>
              <a:defRPr sz="107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44C95-B4EC-4FAD-916A-77A6551C1E81}" type="datetimeFigureOut">
              <a:rPr lang="en-GB" smtClean="0"/>
              <a:t>30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4D227-FDE6-4A7C-849B-13A3A365CF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74370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44C95-B4EC-4FAD-916A-77A6551C1E81}" type="datetimeFigureOut">
              <a:rPr lang="en-GB" smtClean="0"/>
              <a:t>30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4D227-FDE6-4A7C-849B-13A3A365CF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9973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05620" y="365125"/>
            <a:ext cx="1327458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3248" y="365125"/>
            <a:ext cx="39054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44C95-B4EC-4FAD-916A-77A6551C1E81}" type="datetimeFigureOut">
              <a:rPr lang="en-GB" smtClean="0"/>
              <a:t>30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4D227-FDE6-4A7C-849B-13A3A365CF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0620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44C95-B4EC-4FAD-916A-77A6551C1E81}" type="datetimeFigureOut">
              <a:rPr lang="en-GB" smtClean="0"/>
              <a:t>30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4D227-FDE6-4A7C-849B-13A3A365CF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32532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0041" y="1709740"/>
            <a:ext cx="5309830" cy="2852737"/>
          </a:xfrm>
        </p:spPr>
        <p:txBody>
          <a:bodyPr anchor="b"/>
          <a:lstStyle>
            <a:lvl1pPr>
              <a:defRPr sz="40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041" y="4589465"/>
            <a:ext cx="5309830" cy="1500187"/>
          </a:xfrm>
        </p:spPr>
        <p:txBody>
          <a:bodyPr/>
          <a:lstStyle>
            <a:lvl1pPr marL="0" indent="0">
              <a:buNone/>
              <a:defRPr sz="1616">
                <a:solidFill>
                  <a:schemeClr val="tx1"/>
                </a:solidFill>
              </a:defRPr>
            </a:lvl1pPr>
            <a:lvl2pPr marL="307833" indent="0">
              <a:buNone/>
              <a:defRPr sz="1347">
                <a:solidFill>
                  <a:schemeClr val="tx1">
                    <a:tint val="75000"/>
                  </a:schemeClr>
                </a:solidFill>
              </a:defRPr>
            </a:lvl2pPr>
            <a:lvl3pPr marL="615666" indent="0">
              <a:buNone/>
              <a:defRPr sz="1212">
                <a:solidFill>
                  <a:schemeClr val="tx1">
                    <a:tint val="75000"/>
                  </a:schemeClr>
                </a:solidFill>
              </a:defRPr>
            </a:lvl3pPr>
            <a:lvl4pPr marL="923498" indent="0">
              <a:buNone/>
              <a:defRPr sz="1077">
                <a:solidFill>
                  <a:schemeClr val="tx1">
                    <a:tint val="75000"/>
                  </a:schemeClr>
                </a:solidFill>
              </a:defRPr>
            </a:lvl4pPr>
            <a:lvl5pPr marL="1231331" indent="0">
              <a:buNone/>
              <a:defRPr sz="1077">
                <a:solidFill>
                  <a:schemeClr val="tx1">
                    <a:tint val="75000"/>
                  </a:schemeClr>
                </a:solidFill>
              </a:defRPr>
            </a:lvl5pPr>
            <a:lvl6pPr marL="1539164" indent="0">
              <a:buNone/>
              <a:defRPr sz="1077">
                <a:solidFill>
                  <a:schemeClr val="tx1">
                    <a:tint val="75000"/>
                  </a:schemeClr>
                </a:solidFill>
              </a:defRPr>
            </a:lvl6pPr>
            <a:lvl7pPr marL="1846997" indent="0">
              <a:buNone/>
              <a:defRPr sz="1077">
                <a:solidFill>
                  <a:schemeClr val="tx1">
                    <a:tint val="75000"/>
                  </a:schemeClr>
                </a:solidFill>
              </a:defRPr>
            </a:lvl7pPr>
            <a:lvl8pPr marL="2154829" indent="0">
              <a:buNone/>
              <a:defRPr sz="1077">
                <a:solidFill>
                  <a:schemeClr val="tx1">
                    <a:tint val="75000"/>
                  </a:schemeClr>
                </a:solidFill>
              </a:defRPr>
            </a:lvl8pPr>
            <a:lvl9pPr marL="2462662" indent="0">
              <a:buNone/>
              <a:defRPr sz="107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44C95-B4EC-4FAD-916A-77A6551C1E81}" type="datetimeFigureOut">
              <a:rPr lang="en-GB" smtClean="0"/>
              <a:t>30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4D227-FDE6-4A7C-849B-13A3A365CF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5987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3247" y="1825625"/>
            <a:ext cx="2616438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16640" y="1825625"/>
            <a:ext cx="2616438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44C95-B4EC-4FAD-916A-77A6551C1E81}" type="datetimeFigureOut">
              <a:rPr lang="en-GB" smtClean="0"/>
              <a:t>30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4D227-FDE6-4A7C-849B-13A3A365CF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77418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049" y="365127"/>
            <a:ext cx="530983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4050" y="1681163"/>
            <a:ext cx="2604414" cy="823912"/>
          </a:xfrm>
        </p:spPr>
        <p:txBody>
          <a:bodyPr anchor="b"/>
          <a:lstStyle>
            <a:lvl1pPr marL="0" indent="0">
              <a:buNone/>
              <a:defRPr sz="1616" b="1"/>
            </a:lvl1pPr>
            <a:lvl2pPr marL="307833" indent="0">
              <a:buNone/>
              <a:defRPr sz="1347" b="1"/>
            </a:lvl2pPr>
            <a:lvl3pPr marL="615666" indent="0">
              <a:buNone/>
              <a:defRPr sz="1212" b="1"/>
            </a:lvl3pPr>
            <a:lvl4pPr marL="923498" indent="0">
              <a:buNone/>
              <a:defRPr sz="1077" b="1"/>
            </a:lvl4pPr>
            <a:lvl5pPr marL="1231331" indent="0">
              <a:buNone/>
              <a:defRPr sz="1077" b="1"/>
            </a:lvl5pPr>
            <a:lvl6pPr marL="1539164" indent="0">
              <a:buNone/>
              <a:defRPr sz="1077" b="1"/>
            </a:lvl6pPr>
            <a:lvl7pPr marL="1846997" indent="0">
              <a:buNone/>
              <a:defRPr sz="1077" b="1"/>
            </a:lvl7pPr>
            <a:lvl8pPr marL="2154829" indent="0">
              <a:buNone/>
              <a:defRPr sz="1077" b="1"/>
            </a:lvl8pPr>
            <a:lvl9pPr marL="2462662" indent="0">
              <a:buNone/>
              <a:defRPr sz="107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4050" y="2505075"/>
            <a:ext cx="2604414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16640" y="1681163"/>
            <a:ext cx="2617240" cy="823912"/>
          </a:xfrm>
        </p:spPr>
        <p:txBody>
          <a:bodyPr anchor="b"/>
          <a:lstStyle>
            <a:lvl1pPr marL="0" indent="0">
              <a:buNone/>
              <a:defRPr sz="1616" b="1"/>
            </a:lvl1pPr>
            <a:lvl2pPr marL="307833" indent="0">
              <a:buNone/>
              <a:defRPr sz="1347" b="1"/>
            </a:lvl2pPr>
            <a:lvl3pPr marL="615666" indent="0">
              <a:buNone/>
              <a:defRPr sz="1212" b="1"/>
            </a:lvl3pPr>
            <a:lvl4pPr marL="923498" indent="0">
              <a:buNone/>
              <a:defRPr sz="1077" b="1"/>
            </a:lvl4pPr>
            <a:lvl5pPr marL="1231331" indent="0">
              <a:buNone/>
              <a:defRPr sz="1077" b="1"/>
            </a:lvl5pPr>
            <a:lvl6pPr marL="1539164" indent="0">
              <a:buNone/>
              <a:defRPr sz="1077" b="1"/>
            </a:lvl6pPr>
            <a:lvl7pPr marL="1846997" indent="0">
              <a:buNone/>
              <a:defRPr sz="1077" b="1"/>
            </a:lvl7pPr>
            <a:lvl8pPr marL="2154829" indent="0">
              <a:buNone/>
              <a:defRPr sz="1077" b="1"/>
            </a:lvl8pPr>
            <a:lvl9pPr marL="2462662" indent="0">
              <a:buNone/>
              <a:defRPr sz="107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16640" y="2505075"/>
            <a:ext cx="26172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44C95-B4EC-4FAD-916A-77A6551C1E81}" type="datetimeFigureOut">
              <a:rPr lang="en-GB" smtClean="0"/>
              <a:t>30/09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4D227-FDE6-4A7C-849B-13A3A365CF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5416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44C95-B4EC-4FAD-916A-77A6551C1E81}" type="datetimeFigureOut">
              <a:rPr lang="en-GB" smtClean="0"/>
              <a:t>30/09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4D227-FDE6-4A7C-849B-13A3A365CF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6918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44C95-B4EC-4FAD-916A-77A6551C1E81}" type="datetimeFigureOut">
              <a:rPr lang="en-GB" smtClean="0"/>
              <a:t>30/09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4D227-FDE6-4A7C-849B-13A3A365CF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66618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049" y="457200"/>
            <a:ext cx="1985575" cy="1600200"/>
          </a:xfrm>
        </p:spPr>
        <p:txBody>
          <a:bodyPr anchor="b"/>
          <a:lstStyle>
            <a:lvl1pPr>
              <a:defRPr sz="215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17240" y="987427"/>
            <a:ext cx="3116640" cy="4873625"/>
          </a:xfrm>
        </p:spPr>
        <p:txBody>
          <a:bodyPr/>
          <a:lstStyle>
            <a:lvl1pPr>
              <a:defRPr sz="2155"/>
            </a:lvl1pPr>
            <a:lvl2pPr>
              <a:defRPr sz="1885"/>
            </a:lvl2pPr>
            <a:lvl3pPr>
              <a:defRPr sz="1616"/>
            </a:lvl3pPr>
            <a:lvl4pPr>
              <a:defRPr sz="1347"/>
            </a:lvl4pPr>
            <a:lvl5pPr>
              <a:defRPr sz="1347"/>
            </a:lvl5pPr>
            <a:lvl6pPr>
              <a:defRPr sz="1347"/>
            </a:lvl6pPr>
            <a:lvl7pPr>
              <a:defRPr sz="1347"/>
            </a:lvl7pPr>
            <a:lvl8pPr>
              <a:defRPr sz="1347"/>
            </a:lvl8pPr>
            <a:lvl9pPr>
              <a:defRPr sz="134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4049" y="2057400"/>
            <a:ext cx="1985575" cy="3811588"/>
          </a:xfrm>
        </p:spPr>
        <p:txBody>
          <a:bodyPr/>
          <a:lstStyle>
            <a:lvl1pPr marL="0" indent="0">
              <a:buNone/>
              <a:defRPr sz="1077"/>
            </a:lvl1pPr>
            <a:lvl2pPr marL="307833" indent="0">
              <a:buNone/>
              <a:defRPr sz="943"/>
            </a:lvl2pPr>
            <a:lvl3pPr marL="615666" indent="0">
              <a:buNone/>
              <a:defRPr sz="808"/>
            </a:lvl3pPr>
            <a:lvl4pPr marL="923498" indent="0">
              <a:buNone/>
              <a:defRPr sz="673"/>
            </a:lvl4pPr>
            <a:lvl5pPr marL="1231331" indent="0">
              <a:buNone/>
              <a:defRPr sz="673"/>
            </a:lvl5pPr>
            <a:lvl6pPr marL="1539164" indent="0">
              <a:buNone/>
              <a:defRPr sz="673"/>
            </a:lvl6pPr>
            <a:lvl7pPr marL="1846997" indent="0">
              <a:buNone/>
              <a:defRPr sz="673"/>
            </a:lvl7pPr>
            <a:lvl8pPr marL="2154829" indent="0">
              <a:buNone/>
              <a:defRPr sz="673"/>
            </a:lvl8pPr>
            <a:lvl9pPr marL="2462662" indent="0">
              <a:buNone/>
              <a:defRPr sz="67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44C95-B4EC-4FAD-916A-77A6551C1E81}" type="datetimeFigureOut">
              <a:rPr lang="en-GB" smtClean="0"/>
              <a:t>30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4D227-FDE6-4A7C-849B-13A3A365CF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9088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049" y="457200"/>
            <a:ext cx="1985575" cy="1600200"/>
          </a:xfrm>
        </p:spPr>
        <p:txBody>
          <a:bodyPr anchor="b"/>
          <a:lstStyle>
            <a:lvl1pPr>
              <a:defRPr sz="215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17240" y="987427"/>
            <a:ext cx="3116640" cy="4873625"/>
          </a:xfrm>
        </p:spPr>
        <p:txBody>
          <a:bodyPr anchor="t"/>
          <a:lstStyle>
            <a:lvl1pPr marL="0" indent="0">
              <a:buNone/>
              <a:defRPr sz="2155"/>
            </a:lvl1pPr>
            <a:lvl2pPr marL="307833" indent="0">
              <a:buNone/>
              <a:defRPr sz="1885"/>
            </a:lvl2pPr>
            <a:lvl3pPr marL="615666" indent="0">
              <a:buNone/>
              <a:defRPr sz="1616"/>
            </a:lvl3pPr>
            <a:lvl4pPr marL="923498" indent="0">
              <a:buNone/>
              <a:defRPr sz="1347"/>
            </a:lvl4pPr>
            <a:lvl5pPr marL="1231331" indent="0">
              <a:buNone/>
              <a:defRPr sz="1347"/>
            </a:lvl5pPr>
            <a:lvl6pPr marL="1539164" indent="0">
              <a:buNone/>
              <a:defRPr sz="1347"/>
            </a:lvl6pPr>
            <a:lvl7pPr marL="1846997" indent="0">
              <a:buNone/>
              <a:defRPr sz="1347"/>
            </a:lvl7pPr>
            <a:lvl8pPr marL="2154829" indent="0">
              <a:buNone/>
              <a:defRPr sz="1347"/>
            </a:lvl8pPr>
            <a:lvl9pPr marL="2462662" indent="0">
              <a:buNone/>
              <a:defRPr sz="134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4049" y="2057400"/>
            <a:ext cx="1985575" cy="3811588"/>
          </a:xfrm>
        </p:spPr>
        <p:txBody>
          <a:bodyPr/>
          <a:lstStyle>
            <a:lvl1pPr marL="0" indent="0">
              <a:buNone/>
              <a:defRPr sz="1077"/>
            </a:lvl1pPr>
            <a:lvl2pPr marL="307833" indent="0">
              <a:buNone/>
              <a:defRPr sz="943"/>
            </a:lvl2pPr>
            <a:lvl3pPr marL="615666" indent="0">
              <a:buNone/>
              <a:defRPr sz="808"/>
            </a:lvl3pPr>
            <a:lvl4pPr marL="923498" indent="0">
              <a:buNone/>
              <a:defRPr sz="673"/>
            </a:lvl4pPr>
            <a:lvl5pPr marL="1231331" indent="0">
              <a:buNone/>
              <a:defRPr sz="673"/>
            </a:lvl5pPr>
            <a:lvl6pPr marL="1539164" indent="0">
              <a:buNone/>
              <a:defRPr sz="673"/>
            </a:lvl6pPr>
            <a:lvl7pPr marL="1846997" indent="0">
              <a:buNone/>
              <a:defRPr sz="673"/>
            </a:lvl7pPr>
            <a:lvl8pPr marL="2154829" indent="0">
              <a:buNone/>
              <a:defRPr sz="673"/>
            </a:lvl8pPr>
            <a:lvl9pPr marL="2462662" indent="0">
              <a:buNone/>
              <a:defRPr sz="67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44C95-B4EC-4FAD-916A-77A6551C1E81}" type="datetimeFigureOut">
              <a:rPr lang="en-GB" smtClean="0"/>
              <a:t>30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4D227-FDE6-4A7C-849B-13A3A365CF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5940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3248" y="365127"/>
            <a:ext cx="530983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3248" y="1825625"/>
            <a:ext cx="530983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3247" y="6356352"/>
            <a:ext cx="138517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644C95-B4EC-4FAD-916A-77A6551C1E81}" type="datetimeFigureOut">
              <a:rPr lang="en-GB" smtClean="0"/>
              <a:t>30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39283" y="6356352"/>
            <a:ext cx="207776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47905" y="6356352"/>
            <a:ext cx="138517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54D227-FDE6-4A7C-849B-13A3A365CF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054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5666" rtl="0" eaLnBrk="1" latinLnBrk="0" hangingPunct="1">
        <a:lnSpc>
          <a:spcPct val="90000"/>
        </a:lnSpc>
        <a:spcBef>
          <a:spcPct val="0"/>
        </a:spcBef>
        <a:buNone/>
        <a:defRPr sz="296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916" indent="-153916" algn="l" defTabSz="615666" rtl="0" eaLnBrk="1" latinLnBrk="0" hangingPunct="1">
        <a:lnSpc>
          <a:spcPct val="90000"/>
        </a:lnSpc>
        <a:spcBef>
          <a:spcPts val="673"/>
        </a:spcBef>
        <a:buFont typeface="Arial" panose="020B0604020202020204" pitchFamily="34" charset="0"/>
        <a:buChar char="•"/>
        <a:defRPr sz="1885" kern="1200">
          <a:solidFill>
            <a:schemeClr val="tx1"/>
          </a:solidFill>
          <a:latin typeface="+mn-lt"/>
          <a:ea typeface="+mn-ea"/>
          <a:cs typeface="+mn-cs"/>
        </a:defRPr>
      </a:lvl1pPr>
      <a:lvl2pPr marL="461749" indent="-153916" algn="l" defTabSz="615666" rtl="0" eaLnBrk="1" latinLnBrk="0" hangingPunct="1">
        <a:lnSpc>
          <a:spcPct val="90000"/>
        </a:lnSpc>
        <a:spcBef>
          <a:spcPts val="337"/>
        </a:spcBef>
        <a:buFont typeface="Arial" panose="020B0604020202020204" pitchFamily="34" charset="0"/>
        <a:buChar char="•"/>
        <a:defRPr sz="1616" kern="1200">
          <a:solidFill>
            <a:schemeClr val="tx1"/>
          </a:solidFill>
          <a:latin typeface="+mn-lt"/>
          <a:ea typeface="+mn-ea"/>
          <a:cs typeface="+mn-cs"/>
        </a:defRPr>
      </a:lvl2pPr>
      <a:lvl3pPr marL="769582" indent="-153916" algn="l" defTabSz="615666" rtl="0" eaLnBrk="1" latinLnBrk="0" hangingPunct="1">
        <a:lnSpc>
          <a:spcPct val="90000"/>
        </a:lnSpc>
        <a:spcBef>
          <a:spcPts val="337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77415" indent="-153916" algn="l" defTabSz="615666" rtl="0" eaLnBrk="1" latinLnBrk="0" hangingPunct="1">
        <a:lnSpc>
          <a:spcPct val="90000"/>
        </a:lnSpc>
        <a:spcBef>
          <a:spcPts val="337"/>
        </a:spcBef>
        <a:buFont typeface="Arial" panose="020B0604020202020204" pitchFamily="34" charset="0"/>
        <a:buChar char="•"/>
        <a:defRPr sz="1212" kern="1200">
          <a:solidFill>
            <a:schemeClr val="tx1"/>
          </a:solidFill>
          <a:latin typeface="+mn-lt"/>
          <a:ea typeface="+mn-ea"/>
          <a:cs typeface="+mn-cs"/>
        </a:defRPr>
      </a:lvl4pPr>
      <a:lvl5pPr marL="1385247" indent="-153916" algn="l" defTabSz="615666" rtl="0" eaLnBrk="1" latinLnBrk="0" hangingPunct="1">
        <a:lnSpc>
          <a:spcPct val="90000"/>
        </a:lnSpc>
        <a:spcBef>
          <a:spcPts val="337"/>
        </a:spcBef>
        <a:buFont typeface="Arial" panose="020B0604020202020204" pitchFamily="34" charset="0"/>
        <a:buChar char="•"/>
        <a:defRPr sz="1212" kern="1200">
          <a:solidFill>
            <a:schemeClr val="tx1"/>
          </a:solidFill>
          <a:latin typeface="+mn-lt"/>
          <a:ea typeface="+mn-ea"/>
          <a:cs typeface="+mn-cs"/>
        </a:defRPr>
      </a:lvl5pPr>
      <a:lvl6pPr marL="1693080" indent="-153916" algn="l" defTabSz="615666" rtl="0" eaLnBrk="1" latinLnBrk="0" hangingPunct="1">
        <a:lnSpc>
          <a:spcPct val="90000"/>
        </a:lnSpc>
        <a:spcBef>
          <a:spcPts val="337"/>
        </a:spcBef>
        <a:buFont typeface="Arial" panose="020B0604020202020204" pitchFamily="34" charset="0"/>
        <a:buChar char="•"/>
        <a:defRPr sz="1212" kern="1200">
          <a:solidFill>
            <a:schemeClr val="tx1"/>
          </a:solidFill>
          <a:latin typeface="+mn-lt"/>
          <a:ea typeface="+mn-ea"/>
          <a:cs typeface="+mn-cs"/>
        </a:defRPr>
      </a:lvl6pPr>
      <a:lvl7pPr marL="2000913" indent="-153916" algn="l" defTabSz="615666" rtl="0" eaLnBrk="1" latinLnBrk="0" hangingPunct="1">
        <a:lnSpc>
          <a:spcPct val="90000"/>
        </a:lnSpc>
        <a:spcBef>
          <a:spcPts val="337"/>
        </a:spcBef>
        <a:buFont typeface="Arial" panose="020B0604020202020204" pitchFamily="34" charset="0"/>
        <a:buChar char="•"/>
        <a:defRPr sz="1212" kern="1200">
          <a:solidFill>
            <a:schemeClr val="tx1"/>
          </a:solidFill>
          <a:latin typeface="+mn-lt"/>
          <a:ea typeface="+mn-ea"/>
          <a:cs typeface="+mn-cs"/>
        </a:defRPr>
      </a:lvl7pPr>
      <a:lvl8pPr marL="2308746" indent="-153916" algn="l" defTabSz="615666" rtl="0" eaLnBrk="1" latinLnBrk="0" hangingPunct="1">
        <a:lnSpc>
          <a:spcPct val="90000"/>
        </a:lnSpc>
        <a:spcBef>
          <a:spcPts val="337"/>
        </a:spcBef>
        <a:buFont typeface="Arial" panose="020B0604020202020204" pitchFamily="34" charset="0"/>
        <a:buChar char="•"/>
        <a:defRPr sz="1212" kern="1200">
          <a:solidFill>
            <a:schemeClr val="tx1"/>
          </a:solidFill>
          <a:latin typeface="+mn-lt"/>
          <a:ea typeface="+mn-ea"/>
          <a:cs typeface="+mn-cs"/>
        </a:defRPr>
      </a:lvl8pPr>
      <a:lvl9pPr marL="2616578" indent="-153916" algn="l" defTabSz="615666" rtl="0" eaLnBrk="1" latinLnBrk="0" hangingPunct="1">
        <a:lnSpc>
          <a:spcPct val="90000"/>
        </a:lnSpc>
        <a:spcBef>
          <a:spcPts val="337"/>
        </a:spcBef>
        <a:buFont typeface="Arial" panose="020B0604020202020204" pitchFamily="34" charset="0"/>
        <a:buChar char="•"/>
        <a:defRPr sz="121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5666" rtl="0" eaLnBrk="1" latinLnBrk="0" hangingPunct="1">
        <a:defRPr sz="1212" kern="1200">
          <a:solidFill>
            <a:schemeClr val="tx1"/>
          </a:solidFill>
          <a:latin typeface="+mn-lt"/>
          <a:ea typeface="+mn-ea"/>
          <a:cs typeface="+mn-cs"/>
        </a:defRPr>
      </a:lvl1pPr>
      <a:lvl2pPr marL="307833" algn="l" defTabSz="615666" rtl="0" eaLnBrk="1" latinLnBrk="0" hangingPunct="1">
        <a:defRPr sz="1212" kern="1200">
          <a:solidFill>
            <a:schemeClr val="tx1"/>
          </a:solidFill>
          <a:latin typeface="+mn-lt"/>
          <a:ea typeface="+mn-ea"/>
          <a:cs typeface="+mn-cs"/>
        </a:defRPr>
      </a:lvl2pPr>
      <a:lvl3pPr marL="615666" algn="l" defTabSz="615666" rtl="0" eaLnBrk="1" latinLnBrk="0" hangingPunct="1">
        <a:defRPr sz="1212" kern="1200">
          <a:solidFill>
            <a:schemeClr val="tx1"/>
          </a:solidFill>
          <a:latin typeface="+mn-lt"/>
          <a:ea typeface="+mn-ea"/>
          <a:cs typeface="+mn-cs"/>
        </a:defRPr>
      </a:lvl3pPr>
      <a:lvl4pPr marL="923498" algn="l" defTabSz="615666" rtl="0" eaLnBrk="1" latinLnBrk="0" hangingPunct="1">
        <a:defRPr sz="1212" kern="1200">
          <a:solidFill>
            <a:schemeClr val="tx1"/>
          </a:solidFill>
          <a:latin typeface="+mn-lt"/>
          <a:ea typeface="+mn-ea"/>
          <a:cs typeface="+mn-cs"/>
        </a:defRPr>
      </a:lvl4pPr>
      <a:lvl5pPr marL="1231331" algn="l" defTabSz="615666" rtl="0" eaLnBrk="1" latinLnBrk="0" hangingPunct="1">
        <a:defRPr sz="1212" kern="1200">
          <a:solidFill>
            <a:schemeClr val="tx1"/>
          </a:solidFill>
          <a:latin typeface="+mn-lt"/>
          <a:ea typeface="+mn-ea"/>
          <a:cs typeface="+mn-cs"/>
        </a:defRPr>
      </a:lvl5pPr>
      <a:lvl6pPr marL="1539164" algn="l" defTabSz="615666" rtl="0" eaLnBrk="1" latinLnBrk="0" hangingPunct="1">
        <a:defRPr sz="1212" kern="1200">
          <a:solidFill>
            <a:schemeClr val="tx1"/>
          </a:solidFill>
          <a:latin typeface="+mn-lt"/>
          <a:ea typeface="+mn-ea"/>
          <a:cs typeface="+mn-cs"/>
        </a:defRPr>
      </a:lvl6pPr>
      <a:lvl7pPr marL="1846997" algn="l" defTabSz="615666" rtl="0" eaLnBrk="1" latinLnBrk="0" hangingPunct="1">
        <a:defRPr sz="1212" kern="1200">
          <a:solidFill>
            <a:schemeClr val="tx1"/>
          </a:solidFill>
          <a:latin typeface="+mn-lt"/>
          <a:ea typeface="+mn-ea"/>
          <a:cs typeface="+mn-cs"/>
        </a:defRPr>
      </a:lvl7pPr>
      <a:lvl8pPr marL="2154829" algn="l" defTabSz="615666" rtl="0" eaLnBrk="1" latinLnBrk="0" hangingPunct="1">
        <a:defRPr sz="1212" kern="1200">
          <a:solidFill>
            <a:schemeClr val="tx1"/>
          </a:solidFill>
          <a:latin typeface="+mn-lt"/>
          <a:ea typeface="+mn-ea"/>
          <a:cs typeface="+mn-cs"/>
        </a:defRPr>
      </a:lvl8pPr>
      <a:lvl9pPr marL="2462662" algn="l" defTabSz="615666" rtl="0" eaLnBrk="1" latinLnBrk="0" hangingPunct="1">
        <a:defRPr sz="121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w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7AF2ECC-D238-472E-9484-D398974AAD0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0619" y="1283733"/>
            <a:ext cx="1318664" cy="1801725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78B57DB-58F5-4D7F-B341-E36CFB27B98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775"/>
          <a:stretch/>
        </p:blipFill>
        <p:spPr>
          <a:xfrm>
            <a:off x="1561283" y="1283733"/>
            <a:ext cx="1328815" cy="180172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04FF34F-2E47-4BD9-BE72-28C073F41EF8}"/>
              </a:ext>
            </a:extLst>
          </p:cNvPr>
          <p:cNvSpPr txBox="1"/>
          <p:nvPr/>
        </p:nvSpPr>
        <p:spPr>
          <a:xfrm>
            <a:off x="1908347" y="951645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educing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1D73651-51B3-4C5B-A8A5-B363B5CC473D}"/>
              </a:ext>
            </a:extLst>
          </p:cNvPr>
          <p:cNvSpPr txBox="1"/>
          <p:nvPr/>
        </p:nvSpPr>
        <p:spPr>
          <a:xfrm>
            <a:off x="3216545" y="919938"/>
            <a:ext cx="11031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Non-reducing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91E54D56-F7E3-4353-898F-8F3DAA6E4AA2}"/>
              </a:ext>
            </a:extLst>
          </p:cNvPr>
          <p:cNvCxnSpPr/>
          <p:nvPr/>
        </p:nvCxnSpPr>
        <p:spPr>
          <a:xfrm flipV="1">
            <a:off x="4421192" y="1587632"/>
            <a:ext cx="109721" cy="815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81912556-AB74-4C70-8A59-7F4745C91BC1}"/>
              </a:ext>
            </a:extLst>
          </p:cNvPr>
          <p:cNvCxnSpPr/>
          <p:nvPr/>
        </p:nvCxnSpPr>
        <p:spPr>
          <a:xfrm flipV="1">
            <a:off x="4414792" y="1450811"/>
            <a:ext cx="109721" cy="815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3D37E457-B2C9-4079-BAF1-AF64A09965D0}"/>
              </a:ext>
            </a:extLst>
          </p:cNvPr>
          <p:cNvSpPr txBox="1"/>
          <p:nvPr/>
        </p:nvSpPr>
        <p:spPr>
          <a:xfrm>
            <a:off x="4537314" y="1325392"/>
            <a:ext cx="1024639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13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6 polypeptide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9D5F20A-2DBD-4F9A-ABD0-458B7E5CEDFF}"/>
              </a:ext>
            </a:extLst>
          </p:cNvPr>
          <p:cNvSpPr txBox="1"/>
          <p:nvPr/>
        </p:nvSpPr>
        <p:spPr>
          <a:xfrm>
            <a:off x="4537314" y="1467914"/>
            <a:ext cx="1024639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13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3 polypeptides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280B0EE1-25E9-4137-96E4-52968D20FACC}"/>
              </a:ext>
            </a:extLst>
          </p:cNvPr>
          <p:cNvCxnSpPr/>
          <p:nvPr/>
        </p:nvCxnSpPr>
        <p:spPr>
          <a:xfrm flipV="1">
            <a:off x="1419410" y="1490717"/>
            <a:ext cx="109721" cy="815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BE4DA403-1003-4046-A1E1-B49EFFC3687E}"/>
              </a:ext>
            </a:extLst>
          </p:cNvPr>
          <p:cNvCxnSpPr/>
          <p:nvPr/>
        </p:nvCxnSpPr>
        <p:spPr>
          <a:xfrm flipV="1">
            <a:off x="1419410" y="1564829"/>
            <a:ext cx="109721" cy="815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FC6D02AC-03D3-47E5-BB3D-3DD5E3556387}"/>
              </a:ext>
            </a:extLst>
          </p:cNvPr>
          <p:cNvCxnSpPr/>
          <p:nvPr/>
        </p:nvCxnSpPr>
        <p:spPr>
          <a:xfrm flipV="1">
            <a:off x="1419410" y="1650342"/>
            <a:ext cx="109721" cy="815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FED42989-851A-4C66-886C-A7BD63CA615D}"/>
              </a:ext>
            </a:extLst>
          </p:cNvPr>
          <p:cNvCxnSpPr/>
          <p:nvPr/>
        </p:nvCxnSpPr>
        <p:spPr>
          <a:xfrm flipV="1">
            <a:off x="1419410" y="1792863"/>
            <a:ext cx="109721" cy="815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DFACFEB0-8501-465E-BDB5-BB9875A6D9A1}"/>
              </a:ext>
            </a:extLst>
          </p:cNvPr>
          <p:cNvCxnSpPr/>
          <p:nvPr/>
        </p:nvCxnSpPr>
        <p:spPr>
          <a:xfrm flipV="1">
            <a:off x="1419410" y="1906881"/>
            <a:ext cx="109721" cy="815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F033F728-ABE4-422D-837E-664953661FB7}"/>
              </a:ext>
            </a:extLst>
          </p:cNvPr>
          <p:cNvCxnSpPr/>
          <p:nvPr/>
        </p:nvCxnSpPr>
        <p:spPr>
          <a:xfrm flipV="1">
            <a:off x="1425811" y="2129215"/>
            <a:ext cx="109721" cy="815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178BA7FC-B0A6-4F2C-BA92-D12E0CB0E771}"/>
              </a:ext>
            </a:extLst>
          </p:cNvPr>
          <p:cNvCxnSpPr/>
          <p:nvPr/>
        </p:nvCxnSpPr>
        <p:spPr>
          <a:xfrm flipV="1">
            <a:off x="1413010" y="2408557"/>
            <a:ext cx="109721" cy="815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5C786E26-DB15-4EAD-845F-B3D5AFC6A232}"/>
              </a:ext>
            </a:extLst>
          </p:cNvPr>
          <p:cNvCxnSpPr/>
          <p:nvPr/>
        </p:nvCxnSpPr>
        <p:spPr>
          <a:xfrm flipV="1">
            <a:off x="1425811" y="2722105"/>
            <a:ext cx="109721" cy="815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0C50D335-6B8C-4479-A844-8A6B61ACD96F}"/>
              </a:ext>
            </a:extLst>
          </p:cNvPr>
          <p:cNvCxnSpPr/>
          <p:nvPr/>
        </p:nvCxnSpPr>
        <p:spPr>
          <a:xfrm flipV="1">
            <a:off x="1425811" y="2933037"/>
            <a:ext cx="109721" cy="815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2EE5C9A4-1DDD-439F-B638-9443EF0837B5}"/>
              </a:ext>
            </a:extLst>
          </p:cNvPr>
          <p:cNvSpPr txBox="1"/>
          <p:nvPr/>
        </p:nvSpPr>
        <p:spPr>
          <a:xfrm>
            <a:off x="1068602" y="1342495"/>
            <a:ext cx="40107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GB" sz="1013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BC7418B-32F2-4354-BEAB-FEA7B56A8742}"/>
              </a:ext>
            </a:extLst>
          </p:cNvPr>
          <p:cNvSpPr txBox="1"/>
          <p:nvPr/>
        </p:nvSpPr>
        <p:spPr>
          <a:xfrm>
            <a:off x="1075002" y="1467914"/>
            <a:ext cx="40107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GB" sz="1013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BB9A0AF-8148-46BD-AD82-8FF4F5D2CBEC}"/>
              </a:ext>
            </a:extLst>
          </p:cNvPr>
          <p:cNvSpPr txBox="1"/>
          <p:nvPr/>
        </p:nvSpPr>
        <p:spPr>
          <a:xfrm>
            <a:off x="1068602" y="1576230"/>
            <a:ext cx="40107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GB" sz="1013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8336177-D6EB-4CB6-A49D-6890AD474E50}"/>
              </a:ext>
            </a:extLst>
          </p:cNvPr>
          <p:cNvSpPr txBox="1"/>
          <p:nvPr/>
        </p:nvSpPr>
        <p:spPr>
          <a:xfrm>
            <a:off x="1139006" y="1695949"/>
            <a:ext cx="328936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GB" sz="1013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94FFCFA-60DF-463A-AE7B-F02D8272814E}"/>
              </a:ext>
            </a:extLst>
          </p:cNvPr>
          <p:cNvSpPr txBox="1"/>
          <p:nvPr/>
        </p:nvSpPr>
        <p:spPr>
          <a:xfrm>
            <a:off x="1139006" y="1798564"/>
            <a:ext cx="328936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GB" sz="1013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E15ED08-9A56-47F6-B790-E702A5862DE7}"/>
              </a:ext>
            </a:extLst>
          </p:cNvPr>
          <p:cNvSpPr txBox="1"/>
          <p:nvPr/>
        </p:nvSpPr>
        <p:spPr>
          <a:xfrm>
            <a:off x="1145407" y="2009496"/>
            <a:ext cx="328936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GB" sz="1013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8BF4BE2-EC78-4E79-8BCC-F1629ABE122D}"/>
              </a:ext>
            </a:extLst>
          </p:cNvPr>
          <p:cNvSpPr txBox="1"/>
          <p:nvPr/>
        </p:nvSpPr>
        <p:spPr>
          <a:xfrm>
            <a:off x="1139006" y="2277437"/>
            <a:ext cx="328936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GB" sz="1013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6F930B3-D673-47CF-8C2E-FC62AF8E16A3}"/>
              </a:ext>
            </a:extLst>
          </p:cNvPr>
          <p:cNvSpPr txBox="1"/>
          <p:nvPr/>
        </p:nvSpPr>
        <p:spPr>
          <a:xfrm>
            <a:off x="1145407" y="2608087"/>
            <a:ext cx="328936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GB" sz="1013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6EB879F-B5BE-47DF-AA35-2C05F93729FC}"/>
              </a:ext>
            </a:extLst>
          </p:cNvPr>
          <p:cNvSpPr txBox="1"/>
          <p:nvPr/>
        </p:nvSpPr>
        <p:spPr>
          <a:xfrm>
            <a:off x="1151807" y="2836122"/>
            <a:ext cx="328936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GB" sz="1013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6168B13-FFBA-492B-9422-BD078071B0BC}"/>
              </a:ext>
            </a:extLst>
          </p:cNvPr>
          <p:cNvSpPr txBox="1"/>
          <p:nvPr/>
        </p:nvSpPr>
        <p:spPr>
          <a:xfrm>
            <a:off x="1125907" y="1130979"/>
            <a:ext cx="41710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GB" sz="1013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1013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A6655830-9086-47D6-BC6D-1BFBED2B83AB}"/>
              </a:ext>
            </a:extLst>
          </p:cNvPr>
          <p:cNvCxnSpPr/>
          <p:nvPr/>
        </p:nvCxnSpPr>
        <p:spPr>
          <a:xfrm>
            <a:off x="1903555" y="1233595"/>
            <a:ext cx="0" cy="45201"/>
          </a:xfrm>
          <a:prstGeom prst="line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DF784360-7ACB-4309-AF7D-1B668698B90B}"/>
              </a:ext>
            </a:extLst>
          </p:cNvPr>
          <p:cNvCxnSpPr/>
          <p:nvPr/>
        </p:nvCxnSpPr>
        <p:spPr>
          <a:xfrm>
            <a:off x="2194779" y="1233591"/>
            <a:ext cx="0" cy="45201"/>
          </a:xfrm>
          <a:prstGeom prst="line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BBF99C3C-F2D4-46C2-A55B-ED748D5DA152}"/>
              </a:ext>
            </a:extLst>
          </p:cNvPr>
          <p:cNvCxnSpPr/>
          <p:nvPr/>
        </p:nvCxnSpPr>
        <p:spPr>
          <a:xfrm>
            <a:off x="2476397" y="1233588"/>
            <a:ext cx="0" cy="45201"/>
          </a:xfrm>
          <a:prstGeom prst="line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A0292690-F528-423C-A00F-2EEAB86A7A1A}"/>
              </a:ext>
            </a:extLst>
          </p:cNvPr>
          <p:cNvCxnSpPr/>
          <p:nvPr/>
        </p:nvCxnSpPr>
        <p:spPr>
          <a:xfrm>
            <a:off x="2767614" y="1233585"/>
            <a:ext cx="0" cy="45201"/>
          </a:xfrm>
          <a:prstGeom prst="line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8C4F48EB-8968-4715-B331-AFA7FE5CFD8A}"/>
              </a:ext>
            </a:extLst>
          </p:cNvPr>
          <p:cNvCxnSpPr/>
          <p:nvPr/>
        </p:nvCxnSpPr>
        <p:spPr>
          <a:xfrm>
            <a:off x="3414058" y="1230733"/>
            <a:ext cx="0" cy="45201"/>
          </a:xfrm>
          <a:prstGeom prst="line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55B5FF07-D9A4-44BA-BCEB-3FD96AB8BAC6}"/>
              </a:ext>
            </a:extLst>
          </p:cNvPr>
          <p:cNvCxnSpPr/>
          <p:nvPr/>
        </p:nvCxnSpPr>
        <p:spPr>
          <a:xfrm>
            <a:off x="3696830" y="1233583"/>
            <a:ext cx="0" cy="45201"/>
          </a:xfrm>
          <a:prstGeom prst="line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2609AD88-4A9D-44C0-83C0-C33530FF826D}"/>
              </a:ext>
            </a:extLst>
          </p:cNvPr>
          <p:cNvCxnSpPr/>
          <p:nvPr/>
        </p:nvCxnSpPr>
        <p:spPr>
          <a:xfrm>
            <a:off x="3954890" y="1235635"/>
            <a:ext cx="0" cy="45201"/>
          </a:xfrm>
          <a:prstGeom prst="line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AED8751E-9371-4B4E-9231-77E6C42C38B7}"/>
              </a:ext>
            </a:extLst>
          </p:cNvPr>
          <p:cNvCxnSpPr/>
          <p:nvPr/>
        </p:nvCxnSpPr>
        <p:spPr>
          <a:xfrm>
            <a:off x="4220517" y="1233582"/>
            <a:ext cx="0" cy="45201"/>
          </a:xfrm>
          <a:prstGeom prst="line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graphicFrame>
        <p:nvGraphicFramePr>
          <p:cNvPr id="37" name="Object 36">
            <a:extLst>
              <a:ext uri="{FF2B5EF4-FFF2-40B4-BE49-F238E27FC236}">
                <a16:creationId xmlns:a16="http://schemas.microsoft.com/office/drawing/2014/main" id="{1651A63F-A3EA-491C-81EF-2F2210FA82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476506"/>
              </p:ext>
            </p:extLst>
          </p:nvPr>
        </p:nvGraphicFramePr>
        <p:xfrm>
          <a:off x="1582865" y="3271798"/>
          <a:ext cx="2886787" cy="22089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r:id="rId5" imgW="3920760" imgH="3000960" progId="">
                  <p:embed/>
                </p:oleObj>
              </mc:Choice>
              <mc:Fallback>
                <p:oleObj r:id="rId5" imgW="3920760" imgH="3000960" progId="">
                  <p:embed/>
                  <p:pic>
                    <p:nvPicPr>
                      <p:cNvPr id="57" name="Object 56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582865" y="3271798"/>
                        <a:ext cx="2886787" cy="22089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8" name="TextBox 37">
            <a:extLst>
              <a:ext uri="{FF2B5EF4-FFF2-40B4-BE49-F238E27FC236}">
                <a16:creationId xmlns:a16="http://schemas.microsoft.com/office/drawing/2014/main" id="{AFC58C2D-5E68-47E7-B9B1-C9CCB596BF7F}"/>
              </a:ext>
            </a:extLst>
          </p:cNvPr>
          <p:cNvSpPr txBox="1"/>
          <p:nvPr/>
        </p:nvSpPr>
        <p:spPr>
          <a:xfrm>
            <a:off x="1143000" y="83908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CEE6B0E-4CFB-48BE-8BB2-18D2837F73DE}"/>
              </a:ext>
            </a:extLst>
          </p:cNvPr>
          <p:cNvSpPr txBox="1"/>
          <p:nvPr/>
        </p:nvSpPr>
        <p:spPr>
          <a:xfrm>
            <a:off x="1152525" y="321080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55B4B3CA-CA58-4FE4-A78B-2415D25F33DA}"/>
              </a:ext>
            </a:extLst>
          </p:cNvPr>
          <p:cNvCxnSpPr/>
          <p:nvPr/>
        </p:nvCxnSpPr>
        <p:spPr>
          <a:xfrm>
            <a:off x="2416245" y="3592978"/>
            <a:ext cx="0" cy="131037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41254DBA-5B51-4489-8365-12BE4B195D4E}"/>
              </a:ext>
            </a:extLst>
          </p:cNvPr>
          <p:cNvCxnSpPr/>
          <p:nvPr/>
        </p:nvCxnSpPr>
        <p:spPr>
          <a:xfrm>
            <a:off x="2769264" y="3600205"/>
            <a:ext cx="0" cy="131037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A5B280E5-4F32-4D31-B130-72569F771B7C}"/>
              </a:ext>
            </a:extLst>
          </p:cNvPr>
          <p:cNvCxnSpPr/>
          <p:nvPr/>
        </p:nvCxnSpPr>
        <p:spPr>
          <a:xfrm>
            <a:off x="3206641" y="3593914"/>
            <a:ext cx="0" cy="131037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A829B439-9046-4807-A71E-2404A9FBD881}"/>
              </a:ext>
            </a:extLst>
          </p:cNvPr>
          <p:cNvSpPr txBox="1"/>
          <p:nvPr/>
        </p:nvSpPr>
        <p:spPr>
          <a:xfrm>
            <a:off x="3026454" y="3340834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GB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FE086E9-ABDC-427F-8763-2E80BCD46298}"/>
              </a:ext>
            </a:extLst>
          </p:cNvPr>
          <p:cNvSpPr txBox="1"/>
          <p:nvPr/>
        </p:nvSpPr>
        <p:spPr>
          <a:xfrm>
            <a:off x="2536266" y="334712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9CC4C25-C1E7-41DD-B55B-5599C146B9D1}"/>
              </a:ext>
            </a:extLst>
          </p:cNvPr>
          <p:cNvSpPr txBox="1"/>
          <p:nvPr/>
        </p:nvSpPr>
        <p:spPr>
          <a:xfrm>
            <a:off x="2194315" y="334712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74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C5F0F8A7-1248-4105-9226-29EFA857718D}"/>
              </a:ext>
            </a:extLst>
          </p:cNvPr>
          <p:cNvSpPr/>
          <p:nvPr/>
        </p:nvSpPr>
        <p:spPr>
          <a:xfrm>
            <a:off x="324648" y="5938062"/>
            <a:ext cx="550702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. SDS-PAGE and gel filtration analysis of recombinant CL-11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1957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</TotalTime>
  <Words>34</Words>
  <Application>Microsoft Office PowerPoint</Application>
  <PresentationFormat>Custom</PresentationFormat>
  <Paragraphs>2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King's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 Howard</dc:creator>
  <cp:lastModifiedBy>Howard, Mark</cp:lastModifiedBy>
  <cp:revision>4</cp:revision>
  <dcterms:created xsi:type="dcterms:W3CDTF">2019-05-01T12:36:30Z</dcterms:created>
  <dcterms:modified xsi:type="dcterms:W3CDTF">2019-09-30T13:55:48Z</dcterms:modified>
</cp:coreProperties>
</file>